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3401219-35BD-4405-9B5E-5775134C9D78}" v="1" dt="2023-08-07T19:37:23.09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69"/>
  </p:normalViewPr>
  <p:slideViewPr>
    <p:cSldViewPr snapToGrid="0" snapToObjects="1">
      <p:cViewPr varScale="1">
        <p:scale>
          <a:sx n="70" d="100"/>
          <a:sy n="70" d="100"/>
        </p:scale>
        <p:origin x="320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naina Aderaldo" userId="e0012194be11c710" providerId="LiveId" clId="{9ABFC31F-D491-47E1-8BED-240D19443BF1}"/>
    <pc:docChg chg="custSel modSld">
      <pc:chgData name="Janaina Aderaldo" userId="e0012194be11c710" providerId="LiveId" clId="{9ABFC31F-D491-47E1-8BED-240D19443BF1}" dt="2023-01-31T10:14:40.457" v="433" actId="20577"/>
      <pc:docMkLst>
        <pc:docMk/>
      </pc:docMkLst>
      <pc:sldChg chg="addSp delSp modSp mod">
        <pc:chgData name="Janaina Aderaldo" userId="e0012194be11c710" providerId="LiveId" clId="{9ABFC31F-D491-47E1-8BED-240D19443BF1}" dt="2023-01-31T10:14:40.457" v="433" actId="20577"/>
        <pc:sldMkLst>
          <pc:docMk/>
          <pc:sldMk cId="1468538940" sldId="256"/>
        </pc:sldMkLst>
        <pc:spChg chg="mod">
          <ac:chgData name="Janaina Aderaldo" userId="e0012194be11c710" providerId="LiveId" clId="{9ABFC31F-D491-47E1-8BED-240D19443BF1}" dt="2023-01-31T10:14:40.457" v="433" actId="20577"/>
          <ac:spMkLst>
            <pc:docMk/>
            <pc:sldMk cId="1468538940" sldId="256"/>
            <ac:spMk id="19" creationId="{099A9CD4-B024-5F4D-B471-119428DA5039}"/>
          </ac:spMkLst>
        </pc:spChg>
        <pc:spChg chg="mod">
          <ac:chgData name="Janaina Aderaldo" userId="e0012194be11c710" providerId="LiveId" clId="{9ABFC31F-D491-47E1-8BED-240D19443BF1}" dt="2023-01-29T19:15:25.722" v="274" actId="1036"/>
          <ac:spMkLst>
            <pc:docMk/>
            <pc:sldMk cId="1468538940" sldId="256"/>
            <ac:spMk id="20" creationId="{EF82739B-ABE6-E540-8946-165351361045}"/>
          </ac:spMkLst>
        </pc:spChg>
        <pc:spChg chg="mod">
          <ac:chgData name="Janaina Aderaldo" userId="e0012194be11c710" providerId="LiveId" clId="{9ABFC31F-D491-47E1-8BED-240D19443BF1}" dt="2023-01-29T19:15:25.722" v="274" actId="1036"/>
          <ac:spMkLst>
            <pc:docMk/>
            <pc:sldMk cId="1468538940" sldId="256"/>
            <ac:spMk id="23" creationId="{AEC6C648-5B92-4A41-B71F-0BF96B359345}"/>
          </ac:spMkLst>
        </pc:spChg>
        <pc:picChg chg="del">
          <ac:chgData name="Janaina Aderaldo" userId="e0012194be11c710" providerId="LiveId" clId="{9ABFC31F-D491-47E1-8BED-240D19443BF1}" dt="2023-01-29T19:13:06.492" v="144" actId="478"/>
          <ac:picMkLst>
            <pc:docMk/>
            <pc:sldMk cId="1468538940" sldId="256"/>
            <ac:picMk id="3" creationId="{BBD3799D-1E1D-DA4B-B182-5FC60EFEBA6F}"/>
          </ac:picMkLst>
        </pc:picChg>
        <pc:picChg chg="del">
          <ac:chgData name="Janaina Aderaldo" userId="e0012194be11c710" providerId="LiveId" clId="{9ABFC31F-D491-47E1-8BED-240D19443BF1}" dt="2023-01-29T19:09:35.305" v="21" actId="478"/>
          <ac:picMkLst>
            <pc:docMk/>
            <pc:sldMk cId="1468538940" sldId="256"/>
            <ac:picMk id="4" creationId="{8F412A27-C941-8DAE-FE8B-94F05EB50B9F}"/>
          </ac:picMkLst>
        </pc:picChg>
        <pc:picChg chg="del">
          <ac:chgData name="Janaina Aderaldo" userId="e0012194be11c710" providerId="LiveId" clId="{9ABFC31F-D491-47E1-8BED-240D19443BF1}" dt="2023-01-29T19:14:26.342" v="258" actId="478"/>
          <ac:picMkLst>
            <pc:docMk/>
            <pc:sldMk cId="1468538940" sldId="256"/>
            <ac:picMk id="5" creationId="{45C3BFA1-97A5-5D48-B5D8-1E84D03B33EA}"/>
          </ac:picMkLst>
        </pc:picChg>
        <pc:picChg chg="del">
          <ac:chgData name="Janaina Aderaldo" userId="e0012194be11c710" providerId="LiveId" clId="{9ABFC31F-D491-47E1-8BED-240D19443BF1}" dt="2023-01-29T19:15:15.527" v="271" actId="478"/>
          <ac:picMkLst>
            <pc:docMk/>
            <pc:sldMk cId="1468538940" sldId="256"/>
            <ac:picMk id="6" creationId="{1B0F5482-5E63-2249-8AC5-37C4E5C4D378}"/>
          </ac:picMkLst>
        </pc:picChg>
        <pc:picChg chg="del">
          <ac:chgData name="Janaina Aderaldo" userId="e0012194be11c710" providerId="LiveId" clId="{9ABFC31F-D491-47E1-8BED-240D19443BF1}" dt="2023-01-29T19:15:18.548" v="272" actId="478"/>
          <ac:picMkLst>
            <pc:docMk/>
            <pc:sldMk cId="1468538940" sldId="256"/>
            <ac:picMk id="7" creationId="{5468EDA1-6C8A-1344-8EEA-A3D71D760CD5}"/>
          </ac:picMkLst>
        </pc:picChg>
        <pc:picChg chg="add mod">
          <ac:chgData name="Janaina Aderaldo" userId="e0012194be11c710" providerId="LiveId" clId="{9ABFC31F-D491-47E1-8BED-240D19443BF1}" dt="2023-01-29T19:09:45.987" v="24" actId="1076"/>
          <ac:picMkLst>
            <pc:docMk/>
            <pc:sldMk cId="1468538940" sldId="256"/>
            <ac:picMk id="8" creationId="{C4A8B08B-C828-1E8D-B774-E69E51AFEA75}"/>
          </ac:picMkLst>
        </pc:picChg>
        <pc:picChg chg="del">
          <ac:chgData name="Janaina Aderaldo" userId="e0012194be11c710" providerId="LiveId" clId="{9ABFC31F-D491-47E1-8BED-240D19443BF1}" dt="2023-01-29T19:10:33.383" v="105" actId="478"/>
          <ac:picMkLst>
            <pc:docMk/>
            <pc:sldMk cId="1468538940" sldId="256"/>
            <ac:picMk id="10" creationId="{1E3916CF-7085-AA9D-6003-4E7E92B8C1F8}"/>
          </ac:picMkLst>
        </pc:picChg>
        <pc:picChg chg="add mod">
          <ac:chgData name="Janaina Aderaldo" userId="e0012194be11c710" providerId="LiveId" clId="{9ABFC31F-D491-47E1-8BED-240D19443BF1}" dt="2023-01-29T19:10:49.731" v="109" actId="1035"/>
          <ac:picMkLst>
            <pc:docMk/>
            <pc:sldMk cId="1468538940" sldId="256"/>
            <ac:picMk id="13" creationId="{C7854F9E-D83E-828E-97CD-A8978B889FE5}"/>
          </ac:picMkLst>
        </pc:picChg>
        <pc:picChg chg="add mod">
          <ac:chgData name="Janaina Aderaldo" userId="e0012194be11c710" providerId="LiveId" clId="{9ABFC31F-D491-47E1-8BED-240D19443BF1}" dt="2023-01-29T19:13:14.842" v="147" actId="1076"/>
          <ac:picMkLst>
            <pc:docMk/>
            <pc:sldMk cId="1468538940" sldId="256"/>
            <ac:picMk id="15" creationId="{CE942528-6B7C-2D4B-647B-960BD8F292AC}"/>
          </ac:picMkLst>
        </pc:picChg>
        <pc:picChg chg="add mod">
          <ac:chgData name="Janaina Aderaldo" userId="e0012194be11c710" providerId="LiveId" clId="{9ABFC31F-D491-47E1-8BED-240D19443BF1}" dt="2023-01-29T19:14:58.706" v="265" actId="1036"/>
          <ac:picMkLst>
            <pc:docMk/>
            <pc:sldMk cId="1468538940" sldId="256"/>
            <ac:picMk id="17" creationId="{EAA3314B-3CA3-BD99-AF89-4A502020937F}"/>
          </ac:picMkLst>
        </pc:picChg>
        <pc:picChg chg="add mod">
          <ac:chgData name="Janaina Aderaldo" userId="e0012194be11c710" providerId="LiveId" clId="{9ABFC31F-D491-47E1-8BED-240D19443BF1}" dt="2023-01-31T10:12:43.148" v="330" actId="1076"/>
          <ac:picMkLst>
            <pc:docMk/>
            <pc:sldMk cId="1468538940" sldId="256"/>
            <ac:picMk id="24" creationId="{BB927A1F-5EED-D9A7-742A-D25CE95C61BF}"/>
          </ac:picMkLst>
        </pc:picChg>
        <pc:picChg chg="add mod">
          <ac:chgData name="Janaina Aderaldo" userId="e0012194be11c710" providerId="LiveId" clId="{9ABFC31F-D491-47E1-8BED-240D19443BF1}" dt="2023-01-31T10:13:50.564" v="387" actId="1076"/>
          <ac:picMkLst>
            <pc:docMk/>
            <pc:sldMk cId="1468538940" sldId="256"/>
            <ac:picMk id="26" creationId="{5D6A571C-B635-189D-8D17-410A748068F0}"/>
          </ac:picMkLst>
        </pc:picChg>
      </pc:sldChg>
    </pc:docChg>
  </pc:docChgLst>
  <pc:docChgLst>
    <pc:chgData name="Janaina Aderaldo" userId="e0012194be11c710" providerId="LiveId" clId="{3A219E47-389B-4841-9AD4-C56DD6F49493}"/>
    <pc:docChg chg="custSel modSld">
      <pc:chgData name="Janaina Aderaldo" userId="e0012194be11c710" providerId="LiveId" clId="{3A219E47-389B-4841-9AD4-C56DD6F49493}" dt="2023-08-06T12:19:29.556" v="4" actId="478"/>
      <pc:docMkLst>
        <pc:docMk/>
      </pc:docMkLst>
      <pc:sldChg chg="addSp delSp modSp mod">
        <pc:chgData name="Janaina Aderaldo" userId="e0012194be11c710" providerId="LiveId" clId="{3A219E47-389B-4841-9AD4-C56DD6F49493}" dt="2023-08-06T12:19:29.556" v="4" actId="478"/>
        <pc:sldMkLst>
          <pc:docMk/>
          <pc:sldMk cId="1468538940" sldId="256"/>
        </pc:sldMkLst>
        <pc:picChg chg="del">
          <ac:chgData name="Janaina Aderaldo" userId="e0012194be11c710" providerId="LiveId" clId="{3A219E47-389B-4841-9AD4-C56DD6F49493}" dt="2023-08-06T12:16:00.351" v="0" actId="478"/>
          <ac:picMkLst>
            <pc:docMk/>
            <pc:sldMk cId="1468538940" sldId="256"/>
            <ac:picMk id="3" creationId="{99516DC6-AFB1-1F75-E7E5-411856F32AB5}"/>
          </ac:picMkLst>
        </pc:picChg>
        <pc:picChg chg="add mod">
          <ac:chgData name="Janaina Aderaldo" userId="e0012194be11c710" providerId="LiveId" clId="{3A219E47-389B-4841-9AD4-C56DD6F49493}" dt="2023-08-06T12:17:06.522" v="3" actId="1076"/>
          <ac:picMkLst>
            <pc:docMk/>
            <pc:sldMk cId="1468538940" sldId="256"/>
            <ac:picMk id="4" creationId="{62A6470E-3018-6302-31B1-F6CDD2266DAA}"/>
          </ac:picMkLst>
        </pc:picChg>
        <pc:picChg chg="del">
          <ac:chgData name="Janaina Aderaldo" userId="e0012194be11c710" providerId="LiveId" clId="{3A219E47-389B-4841-9AD4-C56DD6F49493}" dt="2023-08-06T12:19:29.556" v="4" actId="478"/>
          <ac:picMkLst>
            <pc:docMk/>
            <pc:sldMk cId="1468538940" sldId="256"/>
            <ac:picMk id="6" creationId="{161CF269-A311-CC15-E092-75F092F78390}"/>
          </ac:picMkLst>
        </pc:picChg>
      </pc:sldChg>
    </pc:docChg>
  </pc:docChgLst>
  <pc:docChgLst>
    <pc:chgData name="Janaina Aderaldo" userId="e0012194be11c710" providerId="Windows Live" clId="Web-{AE01B64F-252A-4457-B33D-C0C67130965D}"/>
    <pc:docChg chg="modSld">
      <pc:chgData name="Janaina Aderaldo" userId="e0012194be11c710" providerId="Windows Live" clId="Web-{AE01B64F-252A-4457-B33D-C0C67130965D}" dt="2022-11-06T21:28:55.136" v="0" actId="20577"/>
      <pc:docMkLst>
        <pc:docMk/>
      </pc:docMkLst>
      <pc:sldChg chg="modSp">
        <pc:chgData name="Janaina Aderaldo" userId="e0012194be11c710" providerId="Windows Live" clId="Web-{AE01B64F-252A-4457-B33D-C0C67130965D}" dt="2022-11-06T21:28:55.136" v="0" actId="20577"/>
        <pc:sldMkLst>
          <pc:docMk/>
          <pc:sldMk cId="1468538940" sldId="256"/>
        </pc:sldMkLst>
        <pc:spChg chg="mod">
          <ac:chgData name="Janaina Aderaldo" userId="e0012194be11c710" providerId="Windows Live" clId="Web-{AE01B64F-252A-4457-B33D-C0C67130965D}" dt="2022-11-06T21:28:55.136" v="0" actId="20577"/>
          <ac:spMkLst>
            <pc:docMk/>
            <pc:sldMk cId="1468538940" sldId="256"/>
            <ac:spMk id="19" creationId="{099A9CD4-B024-5F4D-B471-119428DA5039}"/>
          </ac:spMkLst>
        </pc:spChg>
      </pc:sldChg>
    </pc:docChg>
  </pc:docChgLst>
  <pc:docChgLst>
    <pc:chgData name="Janaina Aderaldo" userId="e0012194be11c710" providerId="LiveId" clId="{EDEA2DAB-3AA9-914B-B75C-81C1AA18433C}"/>
    <pc:docChg chg="custSel modSld">
      <pc:chgData name="Janaina Aderaldo" userId="e0012194be11c710" providerId="LiveId" clId="{EDEA2DAB-3AA9-914B-B75C-81C1AA18433C}" dt="2022-04-03T10:39:55.247" v="345" actId="123"/>
      <pc:docMkLst>
        <pc:docMk/>
      </pc:docMkLst>
      <pc:sldChg chg="addSp delSp modSp mod">
        <pc:chgData name="Janaina Aderaldo" userId="e0012194be11c710" providerId="LiveId" clId="{EDEA2DAB-3AA9-914B-B75C-81C1AA18433C}" dt="2022-04-03T10:39:55.247" v="345" actId="123"/>
        <pc:sldMkLst>
          <pc:docMk/>
          <pc:sldMk cId="1468538940" sldId="256"/>
        </pc:sldMkLst>
        <pc:spChg chg="mod">
          <ac:chgData name="Janaina Aderaldo" userId="e0012194be11c710" providerId="LiveId" clId="{EDEA2DAB-3AA9-914B-B75C-81C1AA18433C}" dt="2022-04-03T10:39:55.247" v="345" actId="123"/>
          <ac:spMkLst>
            <pc:docMk/>
            <pc:sldMk cId="1468538940" sldId="256"/>
            <ac:spMk id="19" creationId="{099A9CD4-B024-5F4D-B471-119428DA5039}"/>
          </ac:spMkLst>
        </pc:spChg>
        <pc:graphicFrameChg chg="add del mod">
          <ac:chgData name="Janaina Aderaldo" userId="e0012194be11c710" providerId="LiveId" clId="{EDEA2DAB-3AA9-914B-B75C-81C1AA18433C}" dt="2022-04-02T22:03:36.359" v="2"/>
          <ac:graphicFrameMkLst>
            <pc:docMk/>
            <pc:sldMk cId="1468538940" sldId="256"/>
            <ac:graphicFrameMk id="2" creationId="{5B981A55-7E29-394B-8989-5832BD467529}"/>
          </ac:graphicFrameMkLst>
        </pc:graphicFrameChg>
        <pc:picChg chg="add mod">
          <ac:chgData name="Janaina Aderaldo" userId="e0012194be11c710" providerId="LiveId" clId="{EDEA2DAB-3AA9-914B-B75C-81C1AA18433C}" dt="2022-04-02T22:06:03.111" v="51" actId="167"/>
          <ac:picMkLst>
            <pc:docMk/>
            <pc:sldMk cId="1468538940" sldId="256"/>
            <ac:picMk id="6" creationId="{1B0F5482-5E63-2249-8AC5-37C4E5C4D378}"/>
          </ac:picMkLst>
        </pc:picChg>
        <pc:picChg chg="mod">
          <ac:chgData name="Janaina Aderaldo" userId="e0012194be11c710" providerId="LiveId" clId="{EDEA2DAB-3AA9-914B-B75C-81C1AA18433C}" dt="2022-04-02T22:06:12.497" v="52" actId="1076"/>
          <ac:picMkLst>
            <pc:docMk/>
            <pc:sldMk cId="1468538940" sldId="256"/>
            <ac:picMk id="7" creationId="{5468EDA1-6C8A-1344-8EEA-A3D71D760CD5}"/>
          </ac:picMkLst>
        </pc:picChg>
        <pc:picChg chg="del">
          <ac:chgData name="Janaina Aderaldo" userId="e0012194be11c710" providerId="LiveId" clId="{EDEA2DAB-3AA9-914B-B75C-81C1AA18433C}" dt="2022-04-02T22:03:33.117" v="0" actId="478"/>
          <ac:picMkLst>
            <pc:docMk/>
            <pc:sldMk cId="1468538940" sldId="256"/>
            <ac:picMk id="10" creationId="{9EB0EB89-04DA-A245-816A-A64FEDB58241}"/>
          </ac:picMkLst>
        </pc:picChg>
      </pc:sldChg>
    </pc:docChg>
  </pc:docChgLst>
  <pc:docChgLst>
    <pc:chgData name="Janaina Aderaldo" userId="e0012194be11c710" providerId="LiveId" clId="{013F41B6-EACB-4B2C-8216-98F1BEE2C7B8}"/>
    <pc:docChg chg="custSel addSld modSld">
      <pc:chgData name="Janaina Aderaldo" userId="e0012194be11c710" providerId="LiveId" clId="{013F41B6-EACB-4B2C-8216-98F1BEE2C7B8}" dt="2023-07-30T20:06:11.330" v="189" actId="20577"/>
      <pc:docMkLst>
        <pc:docMk/>
      </pc:docMkLst>
      <pc:sldChg chg="addSp delSp modSp mod">
        <pc:chgData name="Janaina Aderaldo" userId="e0012194be11c710" providerId="LiveId" clId="{013F41B6-EACB-4B2C-8216-98F1BEE2C7B8}" dt="2023-07-30T19:57:14.843" v="56" actId="20577"/>
        <pc:sldMkLst>
          <pc:docMk/>
          <pc:sldMk cId="1468538940" sldId="256"/>
        </pc:sldMkLst>
        <pc:spChg chg="mod">
          <ac:chgData name="Janaina Aderaldo" userId="e0012194be11c710" providerId="LiveId" clId="{013F41B6-EACB-4B2C-8216-98F1BEE2C7B8}" dt="2023-07-30T19:57:14.843" v="56" actId="20577"/>
          <ac:spMkLst>
            <pc:docMk/>
            <pc:sldMk cId="1468538940" sldId="256"/>
            <ac:spMk id="19" creationId="{099A9CD4-B024-5F4D-B471-119428DA5039}"/>
          </ac:spMkLst>
        </pc:spChg>
        <pc:picChg chg="add del mod">
          <ac:chgData name="Janaina Aderaldo" userId="e0012194be11c710" providerId="LiveId" clId="{013F41B6-EACB-4B2C-8216-98F1BEE2C7B8}" dt="2023-07-30T19:49:43.524" v="7" actId="478"/>
          <ac:picMkLst>
            <pc:docMk/>
            <pc:sldMk cId="1468538940" sldId="256"/>
            <ac:picMk id="3" creationId="{E65FA54A-8C99-9E4E-7563-760FF6336042}"/>
          </ac:picMkLst>
        </pc:picChg>
        <pc:picChg chg="add mod">
          <ac:chgData name="Janaina Aderaldo" userId="e0012194be11c710" providerId="LiveId" clId="{013F41B6-EACB-4B2C-8216-98F1BEE2C7B8}" dt="2023-07-30T19:49:57.781" v="11" actId="1076"/>
          <ac:picMkLst>
            <pc:docMk/>
            <pc:sldMk cId="1468538940" sldId="256"/>
            <ac:picMk id="5" creationId="{92917755-D3B2-D222-CECA-BF537A9DB3AC}"/>
          </ac:picMkLst>
        </pc:picChg>
        <pc:picChg chg="add mod">
          <ac:chgData name="Janaina Aderaldo" userId="e0012194be11c710" providerId="LiveId" clId="{013F41B6-EACB-4B2C-8216-98F1BEE2C7B8}" dt="2023-07-30T19:51:37.654" v="16" actId="1076"/>
          <ac:picMkLst>
            <pc:docMk/>
            <pc:sldMk cId="1468538940" sldId="256"/>
            <ac:picMk id="7" creationId="{400F7636-2437-5945-39E4-3DB54CAD1ED2}"/>
          </ac:picMkLst>
        </pc:picChg>
        <pc:picChg chg="del">
          <ac:chgData name="Janaina Aderaldo" userId="e0012194be11c710" providerId="LiveId" clId="{013F41B6-EACB-4B2C-8216-98F1BEE2C7B8}" dt="2023-07-30T19:07:54.585" v="1" actId="478"/>
          <ac:picMkLst>
            <pc:docMk/>
            <pc:sldMk cId="1468538940" sldId="256"/>
            <ac:picMk id="8" creationId="{C4A8B08B-C828-1E8D-B774-E69E51AFEA75}"/>
          </ac:picMkLst>
        </pc:picChg>
        <pc:picChg chg="add mod">
          <ac:chgData name="Janaina Aderaldo" userId="e0012194be11c710" providerId="LiveId" clId="{013F41B6-EACB-4B2C-8216-98F1BEE2C7B8}" dt="2023-07-30T19:53:13.189" v="20" actId="1076"/>
          <ac:picMkLst>
            <pc:docMk/>
            <pc:sldMk cId="1468538940" sldId="256"/>
            <ac:picMk id="11" creationId="{EE1CB4A7-C4BC-9BCB-DD88-D7C6E49FB4CA}"/>
          </ac:picMkLst>
        </pc:picChg>
        <pc:picChg chg="del">
          <ac:chgData name="Janaina Aderaldo" userId="e0012194be11c710" providerId="LiveId" clId="{013F41B6-EACB-4B2C-8216-98F1BEE2C7B8}" dt="2023-07-30T19:51:20.986" v="12" actId="478"/>
          <ac:picMkLst>
            <pc:docMk/>
            <pc:sldMk cId="1468538940" sldId="256"/>
            <ac:picMk id="13" creationId="{C7854F9E-D83E-828E-97CD-A8978B889FE5}"/>
          </ac:picMkLst>
        </pc:picChg>
        <pc:picChg chg="del">
          <ac:chgData name="Janaina Aderaldo" userId="e0012194be11c710" providerId="LiveId" clId="{013F41B6-EACB-4B2C-8216-98F1BEE2C7B8}" dt="2023-07-30T19:52:57.033" v="17" actId="478"/>
          <ac:picMkLst>
            <pc:docMk/>
            <pc:sldMk cId="1468538940" sldId="256"/>
            <ac:picMk id="15" creationId="{CE942528-6B7C-2D4B-647B-960BD8F292AC}"/>
          </ac:picMkLst>
        </pc:picChg>
        <pc:picChg chg="add mod">
          <ac:chgData name="Janaina Aderaldo" userId="e0012194be11c710" providerId="LiveId" clId="{013F41B6-EACB-4B2C-8216-98F1BEE2C7B8}" dt="2023-07-30T19:54:34.988" v="25" actId="1076"/>
          <ac:picMkLst>
            <pc:docMk/>
            <pc:sldMk cId="1468538940" sldId="256"/>
            <ac:picMk id="16" creationId="{C3F831FE-1C41-4961-16E8-87268CFF508D}"/>
          </ac:picMkLst>
        </pc:picChg>
        <pc:picChg chg="del">
          <ac:chgData name="Janaina Aderaldo" userId="e0012194be11c710" providerId="LiveId" clId="{013F41B6-EACB-4B2C-8216-98F1BEE2C7B8}" dt="2023-07-30T19:54:09.417" v="21" actId="478"/>
          <ac:picMkLst>
            <pc:docMk/>
            <pc:sldMk cId="1468538940" sldId="256"/>
            <ac:picMk id="17" creationId="{EAA3314B-3CA3-BD99-AF89-4A502020937F}"/>
          </ac:picMkLst>
        </pc:picChg>
        <pc:picChg chg="del">
          <ac:chgData name="Janaina Aderaldo" userId="e0012194be11c710" providerId="LiveId" clId="{013F41B6-EACB-4B2C-8216-98F1BEE2C7B8}" dt="2023-07-30T19:55:36.437" v="28" actId="478"/>
          <ac:picMkLst>
            <pc:docMk/>
            <pc:sldMk cId="1468538940" sldId="256"/>
            <ac:picMk id="24" creationId="{BB927A1F-5EED-D9A7-742A-D25CE95C61BF}"/>
          </ac:picMkLst>
        </pc:picChg>
        <pc:picChg chg="add mod">
          <ac:chgData name="Janaina Aderaldo" userId="e0012194be11c710" providerId="LiveId" clId="{013F41B6-EACB-4B2C-8216-98F1BEE2C7B8}" dt="2023-07-30T19:55:42.418" v="29" actId="1076"/>
          <ac:picMkLst>
            <pc:docMk/>
            <pc:sldMk cId="1468538940" sldId="256"/>
            <ac:picMk id="25" creationId="{F7D24349-9470-B21E-5CB1-35E111F50AAC}"/>
          </ac:picMkLst>
        </pc:picChg>
        <pc:picChg chg="del">
          <ac:chgData name="Janaina Aderaldo" userId="e0012194be11c710" providerId="LiveId" clId="{013F41B6-EACB-4B2C-8216-98F1BEE2C7B8}" dt="2023-07-30T19:56:15.232" v="30" actId="478"/>
          <ac:picMkLst>
            <pc:docMk/>
            <pc:sldMk cId="1468538940" sldId="256"/>
            <ac:picMk id="26" creationId="{5D6A571C-B635-189D-8D17-410A748068F0}"/>
          </ac:picMkLst>
        </pc:picChg>
        <pc:picChg chg="add mod">
          <ac:chgData name="Janaina Aderaldo" userId="e0012194be11c710" providerId="LiveId" clId="{013F41B6-EACB-4B2C-8216-98F1BEE2C7B8}" dt="2023-07-30T19:56:52.842" v="34"/>
          <ac:picMkLst>
            <pc:docMk/>
            <pc:sldMk cId="1468538940" sldId="256"/>
            <ac:picMk id="28" creationId="{61743BD7-6586-0022-5AA9-F58A8311B533}"/>
          </ac:picMkLst>
        </pc:picChg>
      </pc:sldChg>
      <pc:sldChg chg="addSp delSp modSp add mod">
        <pc:chgData name="Janaina Aderaldo" userId="e0012194be11c710" providerId="LiveId" clId="{013F41B6-EACB-4B2C-8216-98F1BEE2C7B8}" dt="2023-07-30T20:06:11.330" v="189" actId="20577"/>
        <pc:sldMkLst>
          <pc:docMk/>
          <pc:sldMk cId="2118290558" sldId="257"/>
        </pc:sldMkLst>
        <pc:spChg chg="mod">
          <ac:chgData name="Janaina Aderaldo" userId="e0012194be11c710" providerId="LiveId" clId="{013F41B6-EACB-4B2C-8216-98F1BEE2C7B8}" dt="2023-07-30T20:06:11.330" v="189" actId="20577"/>
          <ac:spMkLst>
            <pc:docMk/>
            <pc:sldMk cId="2118290558" sldId="257"/>
            <ac:spMk id="19" creationId="{099A9CD4-B024-5F4D-B471-119428DA5039}"/>
          </ac:spMkLst>
        </pc:spChg>
        <pc:spChg chg="del mod">
          <ac:chgData name="Janaina Aderaldo" userId="e0012194be11c710" providerId="LiveId" clId="{013F41B6-EACB-4B2C-8216-98F1BEE2C7B8}" dt="2023-07-30T20:06:09.485" v="187"/>
          <ac:spMkLst>
            <pc:docMk/>
            <pc:sldMk cId="2118290558" sldId="257"/>
            <ac:spMk id="20" creationId="{EF82739B-ABE6-E540-8946-165351361045}"/>
          </ac:spMkLst>
        </pc:spChg>
        <pc:spChg chg="del mod">
          <ac:chgData name="Janaina Aderaldo" userId="e0012194be11c710" providerId="LiveId" clId="{013F41B6-EACB-4B2C-8216-98F1BEE2C7B8}" dt="2023-07-30T20:06:09.485" v="185"/>
          <ac:spMkLst>
            <pc:docMk/>
            <pc:sldMk cId="2118290558" sldId="257"/>
            <ac:spMk id="23" creationId="{AEC6C648-5B92-4A41-B71F-0BF96B359345}"/>
          </ac:spMkLst>
        </pc:spChg>
        <pc:picChg chg="add mod">
          <ac:chgData name="Janaina Aderaldo" userId="e0012194be11c710" providerId="LiveId" clId="{013F41B6-EACB-4B2C-8216-98F1BEE2C7B8}" dt="2023-07-30T20:00:47.607" v="101" actId="1076"/>
          <ac:picMkLst>
            <pc:docMk/>
            <pc:sldMk cId="2118290558" sldId="257"/>
            <ac:picMk id="3" creationId="{98FEF230-BDAD-653B-DF87-189BFAF81CC8}"/>
          </ac:picMkLst>
        </pc:picChg>
        <pc:picChg chg="add mod">
          <ac:chgData name="Janaina Aderaldo" userId="e0012194be11c710" providerId="LiveId" clId="{013F41B6-EACB-4B2C-8216-98F1BEE2C7B8}" dt="2023-07-30T20:01:39.405" v="105" actId="1076"/>
          <ac:picMkLst>
            <pc:docMk/>
            <pc:sldMk cId="2118290558" sldId="257"/>
            <ac:picMk id="5" creationId="{E9F87C2D-6270-A20A-05C3-9ECE9386D1E9}"/>
          </ac:picMkLst>
        </pc:picChg>
        <pc:picChg chg="add mod">
          <ac:chgData name="Janaina Aderaldo" userId="e0012194be11c710" providerId="LiveId" clId="{013F41B6-EACB-4B2C-8216-98F1BEE2C7B8}" dt="2023-07-30T20:02:38.481" v="127" actId="1076"/>
          <ac:picMkLst>
            <pc:docMk/>
            <pc:sldMk cId="2118290558" sldId="257"/>
            <ac:picMk id="7" creationId="{1E32558E-9510-ABA9-F504-4C6E2DC56B85}"/>
          </ac:picMkLst>
        </pc:picChg>
        <pc:picChg chg="del">
          <ac:chgData name="Janaina Aderaldo" userId="e0012194be11c710" providerId="LiveId" clId="{013F41B6-EACB-4B2C-8216-98F1BEE2C7B8}" dt="2023-07-30T20:00:36.933" v="98" actId="478"/>
          <ac:picMkLst>
            <pc:docMk/>
            <pc:sldMk cId="2118290558" sldId="257"/>
            <ac:picMk id="8" creationId="{C4A8B08B-C828-1E8D-B774-E69E51AFEA75}"/>
          </ac:picMkLst>
        </pc:picChg>
        <pc:picChg chg="add mod">
          <ac:chgData name="Janaina Aderaldo" userId="e0012194be11c710" providerId="LiveId" clId="{013F41B6-EACB-4B2C-8216-98F1BEE2C7B8}" dt="2023-07-30T20:05:29.899" v="164" actId="1076"/>
          <ac:picMkLst>
            <pc:docMk/>
            <pc:sldMk cId="2118290558" sldId="257"/>
            <ac:picMk id="11" creationId="{BA9F05F7-EA40-339A-9378-650CFAE5118A}"/>
          </ac:picMkLst>
        </pc:picChg>
        <pc:picChg chg="del">
          <ac:chgData name="Janaina Aderaldo" userId="e0012194be11c710" providerId="LiveId" clId="{013F41B6-EACB-4B2C-8216-98F1BEE2C7B8}" dt="2023-07-30T20:01:22.066" v="102" actId="478"/>
          <ac:picMkLst>
            <pc:docMk/>
            <pc:sldMk cId="2118290558" sldId="257"/>
            <ac:picMk id="13" creationId="{C7854F9E-D83E-828E-97CD-A8978B889FE5}"/>
          </ac:picMkLst>
        </pc:picChg>
        <pc:picChg chg="del">
          <ac:chgData name="Janaina Aderaldo" userId="e0012194be11c710" providerId="LiveId" clId="{013F41B6-EACB-4B2C-8216-98F1BEE2C7B8}" dt="2023-07-30T20:02:26.325" v="124" actId="478"/>
          <ac:picMkLst>
            <pc:docMk/>
            <pc:sldMk cId="2118290558" sldId="257"/>
            <ac:picMk id="15" creationId="{CE942528-6B7C-2D4B-647B-960BD8F292AC}"/>
          </ac:picMkLst>
        </pc:picChg>
        <pc:picChg chg="del">
          <ac:chgData name="Janaina Aderaldo" userId="e0012194be11c710" providerId="LiveId" clId="{013F41B6-EACB-4B2C-8216-98F1BEE2C7B8}" dt="2023-07-30T20:05:16.346" v="161" actId="478"/>
          <ac:picMkLst>
            <pc:docMk/>
            <pc:sldMk cId="2118290558" sldId="257"/>
            <ac:picMk id="17" creationId="{EAA3314B-3CA3-BD99-AF89-4A502020937F}"/>
          </ac:picMkLst>
        </pc:picChg>
        <pc:picChg chg="del">
          <ac:chgData name="Janaina Aderaldo" userId="e0012194be11c710" providerId="LiveId" clId="{013F41B6-EACB-4B2C-8216-98F1BEE2C7B8}" dt="2023-07-30T20:06:03.970" v="181" actId="478"/>
          <ac:picMkLst>
            <pc:docMk/>
            <pc:sldMk cId="2118290558" sldId="257"/>
            <ac:picMk id="24" creationId="{BB927A1F-5EED-D9A7-742A-D25CE95C61BF}"/>
          </ac:picMkLst>
        </pc:picChg>
        <pc:picChg chg="del">
          <ac:chgData name="Janaina Aderaldo" userId="e0012194be11c710" providerId="LiveId" clId="{013F41B6-EACB-4B2C-8216-98F1BEE2C7B8}" dt="2023-07-30T20:06:02.651" v="180" actId="478"/>
          <ac:picMkLst>
            <pc:docMk/>
            <pc:sldMk cId="2118290558" sldId="257"/>
            <ac:picMk id="26" creationId="{5D6A571C-B635-189D-8D17-410A748068F0}"/>
          </ac:picMkLst>
        </pc:picChg>
      </pc:sldChg>
    </pc:docChg>
  </pc:docChgLst>
  <pc:docChgLst>
    <pc:chgData name="Janaina Aderaldo" userId="e0012194be11c710" providerId="LiveId" clId="{D84C5511-9110-423F-A457-78B852BC77C9}"/>
    <pc:docChg chg="undo custSel modSld">
      <pc:chgData name="Janaina Aderaldo" userId="e0012194be11c710" providerId="LiveId" clId="{D84C5511-9110-423F-A457-78B852BC77C9}" dt="2023-08-01T13:14:04.396" v="30" actId="1076"/>
      <pc:docMkLst>
        <pc:docMk/>
      </pc:docMkLst>
      <pc:sldChg chg="addSp delSp modSp mod">
        <pc:chgData name="Janaina Aderaldo" userId="e0012194be11c710" providerId="LiveId" clId="{D84C5511-9110-423F-A457-78B852BC77C9}" dt="2023-08-01T13:14:04.396" v="30" actId="1076"/>
        <pc:sldMkLst>
          <pc:docMk/>
          <pc:sldMk cId="1468538940" sldId="256"/>
        </pc:sldMkLst>
        <pc:picChg chg="add mod">
          <ac:chgData name="Janaina Aderaldo" userId="e0012194be11c710" providerId="LiveId" clId="{D84C5511-9110-423F-A457-78B852BC77C9}" dt="2023-08-01T13:11:24.683" v="7" actId="1076"/>
          <ac:picMkLst>
            <pc:docMk/>
            <pc:sldMk cId="1468538940" sldId="256"/>
            <ac:picMk id="3" creationId="{99516DC6-AFB1-1F75-E7E5-411856F32AB5}"/>
          </ac:picMkLst>
        </pc:picChg>
        <pc:picChg chg="add del">
          <ac:chgData name="Janaina Aderaldo" userId="e0012194be11c710" providerId="LiveId" clId="{D84C5511-9110-423F-A457-78B852BC77C9}" dt="2023-08-01T13:11:09.519" v="2" actId="478"/>
          <ac:picMkLst>
            <pc:docMk/>
            <pc:sldMk cId="1468538940" sldId="256"/>
            <ac:picMk id="5" creationId="{92917755-D3B2-D222-CECA-BF537A9DB3AC}"/>
          </ac:picMkLst>
        </pc:picChg>
        <pc:picChg chg="add mod">
          <ac:chgData name="Janaina Aderaldo" userId="e0012194be11c710" providerId="LiveId" clId="{D84C5511-9110-423F-A457-78B852BC77C9}" dt="2023-08-01T13:12:07.571" v="12" actId="1076"/>
          <ac:picMkLst>
            <pc:docMk/>
            <pc:sldMk cId="1468538940" sldId="256"/>
            <ac:picMk id="6" creationId="{161CF269-A311-CC15-E092-75F092F78390}"/>
          </ac:picMkLst>
        </pc:picChg>
        <pc:picChg chg="del">
          <ac:chgData name="Janaina Aderaldo" userId="e0012194be11c710" providerId="LiveId" clId="{D84C5511-9110-423F-A457-78B852BC77C9}" dt="2023-08-01T13:11:55.016" v="8" actId="478"/>
          <ac:picMkLst>
            <pc:docMk/>
            <pc:sldMk cId="1468538940" sldId="256"/>
            <ac:picMk id="7" creationId="{400F7636-2437-5945-39E4-3DB54CAD1ED2}"/>
          </ac:picMkLst>
        </pc:picChg>
        <pc:picChg chg="add mod">
          <ac:chgData name="Janaina Aderaldo" userId="e0012194be11c710" providerId="LiveId" clId="{D84C5511-9110-423F-A457-78B852BC77C9}" dt="2023-08-01T13:12:40.860" v="18" actId="1076"/>
          <ac:picMkLst>
            <pc:docMk/>
            <pc:sldMk cId="1468538940" sldId="256"/>
            <ac:picMk id="10" creationId="{25C2A824-A520-9CA3-A5D9-8FAD83E0685F}"/>
          </ac:picMkLst>
        </pc:picChg>
        <pc:picChg chg="del">
          <ac:chgData name="Janaina Aderaldo" userId="e0012194be11c710" providerId="LiveId" clId="{D84C5511-9110-423F-A457-78B852BC77C9}" dt="2023-08-01T13:12:30.308" v="13" actId="478"/>
          <ac:picMkLst>
            <pc:docMk/>
            <pc:sldMk cId="1468538940" sldId="256"/>
            <ac:picMk id="11" creationId="{EE1CB4A7-C4BC-9BCB-DD88-D7C6E49FB4CA}"/>
          </ac:picMkLst>
        </pc:picChg>
        <pc:picChg chg="add mod">
          <ac:chgData name="Janaina Aderaldo" userId="e0012194be11c710" providerId="LiveId" clId="{D84C5511-9110-423F-A457-78B852BC77C9}" dt="2023-08-01T13:13:13.997" v="22" actId="1076"/>
          <ac:picMkLst>
            <pc:docMk/>
            <pc:sldMk cId="1468538940" sldId="256"/>
            <ac:picMk id="14" creationId="{1ADA4890-D036-B833-4F01-4AE71947C15A}"/>
          </ac:picMkLst>
        </pc:picChg>
        <pc:picChg chg="del">
          <ac:chgData name="Janaina Aderaldo" userId="e0012194be11c710" providerId="LiveId" clId="{D84C5511-9110-423F-A457-78B852BC77C9}" dt="2023-08-01T13:13:05.244" v="19" actId="478"/>
          <ac:picMkLst>
            <pc:docMk/>
            <pc:sldMk cId="1468538940" sldId="256"/>
            <ac:picMk id="16" creationId="{C3F831FE-1C41-4961-16E8-87268CFF508D}"/>
          </ac:picMkLst>
        </pc:picChg>
        <pc:picChg chg="add mod">
          <ac:chgData name="Janaina Aderaldo" userId="e0012194be11c710" providerId="LiveId" clId="{D84C5511-9110-423F-A457-78B852BC77C9}" dt="2023-08-01T13:13:39.845" v="26" actId="1076"/>
          <ac:picMkLst>
            <pc:docMk/>
            <pc:sldMk cId="1468538940" sldId="256"/>
            <ac:picMk id="17" creationId="{BE276843-6876-ACFB-44B3-60259C2E14F7}"/>
          </ac:picMkLst>
        </pc:picChg>
        <pc:picChg chg="add mod">
          <ac:chgData name="Janaina Aderaldo" userId="e0012194be11c710" providerId="LiveId" clId="{D84C5511-9110-423F-A457-78B852BC77C9}" dt="2023-08-01T13:14:04.396" v="30" actId="1076"/>
          <ac:picMkLst>
            <pc:docMk/>
            <pc:sldMk cId="1468538940" sldId="256"/>
            <ac:picMk id="24" creationId="{074DC259-696B-5168-8AB8-29B2816C399C}"/>
          </ac:picMkLst>
        </pc:picChg>
        <pc:picChg chg="del">
          <ac:chgData name="Janaina Aderaldo" userId="e0012194be11c710" providerId="LiveId" clId="{D84C5511-9110-423F-A457-78B852BC77C9}" dt="2023-08-01T13:13:33.672" v="23" actId="478"/>
          <ac:picMkLst>
            <pc:docMk/>
            <pc:sldMk cId="1468538940" sldId="256"/>
            <ac:picMk id="25" creationId="{F7D24349-9470-B21E-5CB1-35E111F50AAC}"/>
          </ac:picMkLst>
        </pc:picChg>
        <pc:picChg chg="del">
          <ac:chgData name="Janaina Aderaldo" userId="e0012194be11c710" providerId="LiveId" clId="{D84C5511-9110-423F-A457-78B852BC77C9}" dt="2023-08-01T13:13:54.439" v="27" actId="478"/>
          <ac:picMkLst>
            <pc:docMk/>
            <pc:sldMk cId="1468538940" sldId="256"/>
            <ac:picMk id="28" creationId="{61743BD7-6586-0022-5AA9-F58A8311B533}"/>
          </ac:picMkLst>
        </pc:picChg>
      </pc:sldChg>
    </pc:docChg>
  </pc:docChgLst>
  <pc:docChgLst>
    <pc:chgData name="Janaina Aderaldo" userId="e0012194be11c710" providerId="LiveId" clId="{C0B2C799-53BE-4C87-989A-1CC363206755}"/>
    <pc:docChg chg="modSld">
      <pc:chgData name="Janaina Aderaldo" userId="e0012194be11c710" providerId="LiveId" clId="{C0B2C799-53BE-4C87-989A-1CC363206755}" dt="2023-02-02T10:25:55.526" v="5" actId="6549"/>
      <pc:docMkLst>
        <pc:docMk/>
      </pc:docMkLst>
      <pc:sldChg chg="modSp mod">
        <pc:chgData name="Janaina Aderaldo" userId="e0012194be11c710" providerId="LiveId" clId="{C0B2C799-53BE-4C87-989A-1CC363206755}" dt="2023-02-02T10:25:55.526" v="5" actId="6549"/>
        <pc:sldMkLst>
          <pc:docMk/>
          <pc:sldMk cId="1468538940" sldId="256"/>
        </pc:sldMkLst>
        <pc:spChg chg="mod">
          <ac:chgData name="Janaina Aderaldo" userId="e0012194be11c710" providerId="LiveId" clId="{C0B2C799-53BE-4C87-989A-1CC363206755}" dt="2023-02-02T10:25:55.526" v="5" actId="6549"/>
          <ac:spMkLst>
            <pc:docMk/>
            <pc:sldMk cId="1468538940" sldId="256"/>
            <ac:spMk id="19" creationId="{099A9CD4-B024-5F4D-B471-119428DA5039}"/>
          </ac:spMkLst>
        </pc:spChg>
      </pc:sldChg>
    </pc:docChg>
  </pc:docChgLst>
  <pc:docChgLst>
    <pc:chgData name="Janaina Aderaldo" userId="e0012194be11c710" providerId="LiveId" clId="{0B6676A9-C813-3045-B4EF-0BEAFF5FA739}"/>
    <pc:docChg chg="modSld">
      <pc:chgData name="Janaina Aderaldo" userId="e0012194be11c710" providerId="LiveId" clId="{0B6676A9-C813-3045-B4EF-0BEAFF5FA739}" dt="2022-04-01T10:56:03.638" v="149" actId="20577"/>
      <pc:docMkLst>
        <pc:docMk/>
      </pc:docMkLst>
      <pc:sldChg chg="addSp modSp mod">
        <pc:chgData name="Janaina Aderaldo" userId="e0012194be11c710" providerId="LiveId" clId="{0B6676A9-C813-3045-B4EF-0BEAFF5FA739}" dt="2022-04-01T10:56:03.638" v="149" actId="20577"/>
        <pc:sldMkLst>
          <pc:docMk/>
          <pc:sldMk cId="1468538940" sldId="256"/>
        </pc:sldMkLst>
        <pc:spChg chg="add mod">
          <ac:chgData name="Janaina Aderaldo" userId="e0012194be11c710" providerId="LiveId" clId="{0B6676A9-C813-3045-B4EF-0BEAFF5FA739}" dt="2022-04-01T10:52:27.009" v="9" actId="1076"/>
          <ac:spMkLst>
            <pc:docMk/>
            <pc:sldMk cId="1468538940" sldId="256"/>
            <ac:spMk id="9" creationId="{5AD4CC3F-02CB-EC47-BCC6-8F505DD4C900}"/>
          </ac:spMkLst>
        </pc:spChg>
        <pc:spChg chg="add mod">
          <ac:chgData name="Janaina Aderaldo" userId="e0012194be11c710" providerId="LiveId" clId="{0B6676A9-C813-3045-B4EF-0BEAFF5FA739}" dt="2022-04-01T10:53:06.672" v="18" actId="1076"/>
          <ac:spMkLst>
            <pc:docMk/>
            <pc:sldMk cId="1468538940" sldId="256"/>
            <ac:spMk id="12" creationId="{33EADA68-5597-CB43-9819-273C567FB1DA}"/>
          </ac:spMkLst>
        </pc:spChg>
        <pc:spChg chg="mod">
          <ac:chgData name="Janaina Aderaldo" userId="e0012194be11c710" providerId="LiveId" clId="{0B6676A9-C813-3045-B4EF-0BEAFF5FA739}" dt="2022-04-01T10:56:03.638" v="149" actId="20577"/>
          <ac:spMkLst>
            <pc:docMk/>
            <pc:sldMk cId="1468538940" sldId="256"/>
            <ac:spMk id="19" creationId="{099A9CD4-B024-5F4D-B471-119428DA5039}"/>
          </ac:spMkLst>
        </pc:spChg>
        <pc:spChg chg="add mod">
          <ac:chgData name="Janaina Aderaldo" userId="e0012194be11c710" providerId="LiveId" clId="{0B6676A9-C813-3045-B4EF-0BEAFF5FA739}" dt="2022-04-01T10:54:17.077" v="37" actId="1076"/>
          <ac:spMkLst>
            <pc:docMk/>
            <pc:sldMk cId="1468538940" sldId="256"/>
            <ac:spMk id="20" creationId="{EF82739B-ABE6-E540-8946-165351361045}"/>
          </ac:spMkLst>
        </pc:spChg>
        <pc:spChg chg="add mod">
          <ac:chgData name="Janaina Aderaldo" userId="e0012194be11c710" providerId="LiveId" clId="{0B6676A9-C813-3045-B4EF-0BEAFF5FA739}" dt="2022-04-01T10:54:05.990" v="34" actId="1076"/>
          <ac:spMkLst>
            <pc:docMk/>
            <pc:sldMk cId="1468538940" sldId="256"/>
            <ac:spMk id="23" creationId="{AEC6C648-5B92-4A41-B71F-0BF96B359345}"/>
          </ac:spMkLst>
        </pc:spChg>
        <pc:picChg chg="add mod">
          <ac:chgData name="Janaina Aderaldo" userId="e0012194be11c710" providerId="LiveId" clId="{0B6676A9-C813-3045-B4EF-0BEAFF5FA739}" dt="2022-04-01T10:51:58.578" v="4" actId="1076"/>
          <ac:picMkLst>
            <pc:docMk/>
            <pc:sldMk cId="1468538940" sldId="256"/>
            <ac:picMk id="3" creationId="{BBD3799D-1E1D-DA4B-B182-5FC60EFEBA6F}"/>
          </ac:picMkLst>
        </pc:picChg>
        <pc:picChg chg="add mod">
          <ac:chgData name="Janaina Aderaldo" userId="e0012194be11c710" providerId="LiveId" clId="{0B6676A9-C813-3045-B4EF-0BEAFF5FA739}" dt="2022-04-01T10:52:52.480" v="14" actId="1076"/>
          <ac:picMkLst>
            <pc:docMk/>
            <pc:sldMk cId="1468538940" sldId="256"/>
            <ac:picMk id="5" creationId="{45C3BFA1-97A5-5D48-B5D8-1E84D03B33EA}"/>
          </ac:picMkLst>
        </pc:picChg>
        <pc:picChg chg="add mod">
          <ac:chgData name="Janaina Aderaldo" userId="e0012194be11c710" providerId="LiveId" clId="{0B6676A9-C813-3045-B4EF-0BEAFF5FA739}" dt="2022-04-01T10:53:32.399" v="24" actId="1076"/>
          <ac:picMkLst>
            <pc:docMk/>
            <pc:sldMk cId="1468538940" sldId="256"/>
            <ac:picMk id="7" creationId="{5468EDA1-6C8A-1344-8EEA-A3D71D760CD5}"/>
          </ac:picMkLst>
        </pc:picChg>
        <pc:picChg chg="add mod">
          <ac:chgData name="Janaina Aderaldo" userId="e0012194be11c710" providerId="LiveId" clId="{0B6676A9-C813-3045-B4EF-0BEAFF5FA739}" dt="2022-04-01T10:53:49.374" v="29" actId="1076"/>
          <ac:picMkLst>
            <pc:docMk/>
            <pc:sldMk cId="1468538940" sldId="256"/>
            <ac:picMk id="10" creationId="{9EB0EB89-04DA-A245-816A-A64FEDB58241}"/>
          </ac:picMkLst>
        </pc:picChg>
      </pc:sldChg>
    </pc:docChg>
  </pc:docChgLst>
  <pc:docChgLst>
    <pc:chgData name="Janaina Aderaldo" userId="e0012194be11c710" providerId="LiveId" clId="{B3401219-35BD-4405-9B5E-5775134C9D78}"/>
    <pc:docChg chg="custSel modSld">
      <pc:chgData name="Janaina Aderaldo" userId="e0012194be11c710" providerId="LiveId" clId="{B3401219-35BD-4405-9B5E-5775134C9D78}" dt="2023-08-07T19:37:23.094" v="29"/>
      <pc:docMkLst>
        <pc:docMk/>
      </pc:docMkLst>
      <pc:sldChg chg="addSp delSp modSp mod">
        <pc:chgData name="Janaina Aderaldo" userId="e0012194be11c710" providerId="LiveId" clId="{B3401219-35BD-4405-9B5E-5775134C9D78}" dt="2023-08-07T19:37:23.094" v="29"/>
        <pc:sldMkLst>
          <pc:docMk/>
          <pc:sldMk cId="1468538940" sldId="256"/>
        </pc:sldMkLst>
        <pc:spChg chg="mod">
          <ac:chgData name="Janaina Aderaldo" userId="e0012194be11c710" providerId="LiveId" clId="{B3401219-35BD-4405-9B5E-5775134C9D78}" dt="2023-08-07T19:37:23.094" v="29"/>
          <ac:spMkLst>
            <pc:docMk/>
            <pc:sldMk cId="1468538940" sldId="256"/>
            <ac:spMk id="19" creationId="{099A9CD4-B024-5F4D-B471-119428DA5039}"/>
          </ac:spMkLst>
        </pc:spChg>
        <pc:picChg chg="add mod">
          <ac:chgData name="Janaina Aderaldo" userId="e0012194be11c710" providerId="LiveId" clId="{B3401219-35BD-4405-9B5E-5775134C9D78}" dt="2023-08-07T19:35:02.567" v="2" actId="1076"/>
          <ac:picMkLst>
            <pc:docMk/>
            <pc:sldMk cId="1468538940" sldId="256"/>
            <ac:picMk id="3" creationId="{EF856564-5AE3-E77E-EDB1-B7425BD47302}"/>
          </ac:picMkLst>
        </pc:picChg>
        <pc:picChg chg="add mod">
          <ac:chgData name="Janaina Aderaldo" userId="e0012194be11c710" providerId="LiveId" clId="{B3401219-35BD-4405-9B5E-5775134C9D78}" dt="2023-08-07T19:35:35.384" v="6" actId="1076"/>
          <ac:picMkLst>
            <pc:docMk/>
            <pc:sldMk cId="1468538940" sldId="256"/>
            <ac:picMk id="6" creationId="{0145DE5E-E9A9-232E-73FF-F8DA5327225F}"/>
          </ac:picMkLst>
        </pc:picChg>
        <pc:picChg chg="add mod">
          <ac:chgData name="Janaina Aderaldo" userId="e0012194be11c710" providerId="LiveId" clId="{B3401219-35BD-4405-9B5E-5775134C9D78}" dt="2023-08-07T19:36:12.055" v="10" actId="1076"/>
          <ac:picMkLst>
            <pc:docMk/>
            <pc:sldMk cId="1468538940" sldId="256"/>
            <ac:picMk id="8" creationId="{54B8DE21-A6B4-1E16-60B7-CF5055C9DEE3}"/>
          </ac:picMkLst>
        </pc:picChg>
        <pc:picChg chg="del">
          <ac:chgData name="Janaina Aderaldo" userId="e0012194be11c710" providerId="LiveId" clId="{B3401219-35BD-4405-9B5E-5775134C9D78}" dt="2023-08-07T19:35:04.900" v="3" actId="478"/>
          <ac:picMkLst>
            <pc:docMk/>
            <pc:sldMk cId="1468538940" sldId="256"/>
            <ac:picMk id="10" creationId="{25C2A824-A520-9CA3-A5D9-8FAD83E0685F}"/>
          </ac:picMkLst>
        </pc:picChg>
        <pc:picChg chg="add mod">
          <ac:chgData name="Janaina Aderaldo" userId="e0012194be11c710" providerId="LiveId" clId="{B3401219-35BD-4405-9B5E-5775134C9D78}" dt="2023-08-07T19:36:38.447" v="14" actId="1076"/>
          <ac:picMkLst>
            <pc:docMk/>
            <pc:sldMk cId="1468538940" sldId="256"/>
            <ac:picMk id="13" creationId="{6ED4DCB8-602E-3DB3-5BD6-E9EDE5FDEF26}"/>
          </ac:picMkLst>
        </pc:picChg>
        <pc:picChg chg="del">
          <ac:chgData name="Janaina Aderaldo" userId="e0012194be11c710" providerId="LiveId" clId="{B3401219-35BD-4405-9B5E-5775134C9D78}" dt="2023-08-07T19:35:37.147" v="7" actId="478"/>
          <ac:picMkLst>
            <pc:docMk/>
            <pc:sldMk cId="1468538940" sldId="256"/>
            <ac:picMk id="14" creationId="{1ADA4890-D036-B833-4F01-4AE71947C15A}"/>
          </ac:picMkLst>
        </pc:picChg>
        <pc:picChg chg="add mod">
          <ac:chgData name="Janaina Aderaldo" userId="e0012194be11c710" providerId="LiveId" clId="{B3401219-35BD-4405-9B5E-5775134C9D78}" dt="2023-08-07T19:37:05.632" v="18" actId="1076"/>
          <ac:picMkLst>
            <pc:docMk/>
            <pc:sldMk cId="1468538940" sldId="256"/>
            <ac:picMk id="16" creationId="{CF6B5420-CBB6-E893-0C0E-5A3A18839D2C}"/>
          </ac:picMkLst>
        </pc:picChg>
        <pc:picChg chg="del">
          <ac:chgData name="Janaina Aderaldo" userId="e0012194be11c710" providerId="LiveId" clId="{B3401219-35BD-4405-9B5E-5775134C9D78}" dt="2023-08-07T19:36:13.587" v="11" actId="478"/>
          <ac:picMkLst>
            <pc:docMk/>
            <pc:sldMk cId="1468538940" sldId="256"/>
            <ac:picMk id="17" creationId="{BE276843-6876-ACFB-44B3-60259C2E14F7}"/>
          </ac:picMkLst>
        </pc:picChg>
        <pc:picChg chg="del">
          <ac:chgData name="Janaina Aderaldo" userId="e0012194be11c710" providerId="LiveId" clId="{B3401219-35BD-4405-9B5E-5775134C9D78}" dt="2023-08-07T19:36:40.970" v="15" actId="478"/>
          <ac:picMkLst>
            <pc:docMk/>
            <pc:sldMk cId="1468538940" sldId="256"/>
            <ac:picMk id="24" creationId="{074DC259-696B-5168-8AB8-29B2816C399C}"/>
          </ac:picMkLst>
        </pc:picChg>
      </pc:sldChg>
      <pc:sldChg chg="modSp">
        <pc:chgData name="Janaina Aderaldo" userId="e0012194be11c710" providerId="LiveId" clId="{B3401219-35BD-4405-9B5E-5775134C9D78}" dt="2023-08-07T19:37:23.094" v="29"/>
        <pc:sldMkLst>
          <pc:docMk/>
          <pc:sldMk cId="2118290558" sldId="257"/>
        </pc:sldMkLst>
        <pc:spChg chg="mod">
          <ac:chgData name="Janaina Aderaldo" userId="e0012194be11c710" providerId="LiveId" clId="{B3401219-35BD-4405-9B5E-5775134C9D78}" dt="2023-08-07T19:37:23.094" v="29"/>
          <ac:spMkLst>
            <pc:docMk/>
            <pc:sldMk cId="2118290558" sldId="257"/>
            <ac:spMk id="19" creationId="{099A9CD4-B024-5F4D-B471-119428DA5039}"/>
          </ac:spMkLst>
        </pc:spChg>
      </pc:sldChg>
    </pc:docChg>
  </pc:docChgLst>
  <pc:docChgLst>
    <pc:chgData name="Janaina Aderaldo" userId="e0012194be11c710" providerId="LiveId" clId="{BE4EADF0-0C0B-4CEF-911B-90F73FB92925}"/>
    <pc:docChg chg="undo custSel addSld delSld modSld">
      <pc:chgData name="Janaina Aderaldo" userId="e0012194be11c710" providerId="LiveId" clId="{BE4EADF0-0C0B-4CEF-911B-90F73FB92925}" dt="2023-01-09T09:44:45.992" v="63" actId="20577"/>
      <pc:docMkLst>
        <pc:docMk/>
      </pc:docMkLst>
      <pc:sldChg chg="addSp delSp modSp mod">
        <pc:chgData name="Janaina Aderaldo" userId="e0012194be11c710" providerId="LiveId" clId="{BE4EADF0-0C0B-4CEF-911B-90F73FB92925}" dt="2023-01-09T09:44:45.992" v="63" actId="20577"/>
        <pc:sldMkLst>
          <pc:docMk/>
          <pc:sldMk cId="1468538940" sldId="256"/>
        </pc:sldMkLst>
        <pc:spChg chg="mod">
          <ac:chgData name="Janaina Aderaldo" userId="e0012194be11c710" providerId="LiveId" clId="{BE4EADF0-0C0B-4CEF-911B-90F73FB92925}" dt="2023-01-09T09:44:45.992" v="63" actId="20577"/>
          <ac:spMkLst>
            <pc:docMk/>
            <pc:sldMk cId="1468538940" sldId="256"/>
            <ac:spMk id="19" creationId="{099A9CD4-B024-5F4D-B471-119428DA5039}"/>
          </ac:spMkLst>
        </pc:spChg>
        <pc:picChg chg="add mod">
          <ac:chgData name="Janaina Aderaldo" userId="e0012194be11c710" providerId="LiveId" clId="{BE4EADF0-0C0B-4CEF-911B-90F73FB92925}" dt="2023-01-09T09:43:32.508" v="44" actId="1036"/>
          <ac:picMkLst>
            <pc:docMk/>
            <pc:sldMk cId="1468538940" sldId="256"/>
            <ac:picMk id="4" creationId="{8F412A27-C941-8DAE-FE8B-94F05EB50B9F}"/>
          </ac:picMkLst>
        </pc:picChg>
        <pc:picChg chg="add mod">
          <ac:chgData name="Janaina Aderaldo" userId="e0012194be11c710" providerId="LiveId" clId="{BE4EADF0-0C0B-4CEF-911B-90F73FB92925}" dt="2023-01-09T09:44:36.207" v="48" actId="1076"/>
          <ac:picMkLst>
            <pc:docMk/>
            <pc:sldMk cId="1468538940" sldId="256"/>
            <ac:picMk id="10" creationId="{1E3916CF-7085-AA9D-6003-4E7E92B8C1F8}"/>
          </ac:picMkLst>
        </pc:picChg>
        <pc:picChg chg="del">
          <ac:chgData name="Janaina Aderaldo" userId="e0012194be11c710" providerId="LiveId" clId="{BE4EADF0-0C0B-4CEF-911B-90F73FB92925}" dt="2023-01-09T09:42:56.621" v="26" actId="478"/>
          <ac:picMkLst>
            <pc:docMk/>
            <pc:sldMk cId="1468538940" sldId="256"/>
            <ac:picMk id="17" creationId="{CE89F616-6FB0-2C42-9DB1-C84F590471AF}"/>
          </ac:picMkLst>
        </pc:picChg>
        <pc:picChg chg="del">
          <ac:chgData name="Janaina Aderaldo" userId="e0012194be11c710" providerId="LiveId" clId="{BE4EADF0-0C0B-4CEF-911B-90F73FB92925}" dt="2023-01-09T09:44:28.178" v="45" actId="478"/>
          <ac:picMkLst>
            <pc:docMk/>
            <pc:sldMk cId="1468538940" sldId="256"/>
            <ac:picMk id="21" creationId="{8890FCB7-96F7-3D4C-A233-D4F5FA33728F}"/>
          </ac:picMkLst>
        </pc:picChg>
      </pc:sldChg>
      <pc:sldChg chg="add del">
        <pc:chgData name="Janaina Aderaldo" userId="e0012194be11c710" providerId="LiveId" clId="{BE4EADF0-0C0B-4CEF-911B-90F73FB92925}" dt="2023-01-09T09:42:59.944" v="28"/>
        <pc:sldMkLst>
          <pc:docMk/>
          <pc:sldMk cId="467337693" sldId="257"/>
        </pc:sldMkLst>
      </pc:sldChg>
      <pc:sldChg chg="add del">
        <pc:chgData name="Janaina Aderaldo" userId="e0012194be11c710" providerId="LiveId" clId="{BE4EADF0-0C0B-4CEF-911B-90F73FB92925}" dt="2023-01-09T09:42:43.604" v="6" actId="47"/>
        <pc:sldMkLst>
          <pc:docMk/>
          <pc:sldMk cId="1286766328" sldId="257"/>
        </pc:sldMkLst>
      </pc:sldChg>
      <pc:sldChg chg="addSp delSp new del mod">
        <pc:chgData name="Janaina Aderaldo" userId="e0012194be11c710" providerId="LiveId" clId="{BE4EADF0-0C0B-4CEF-911B-90F73FB92925}" dt="2023-01-09T09:42:37.850" v="4" actId="47"/>
        <pc:sldMkLst>
          <pc:docMk/>
          <pc:sldMk cId="3959218598" sldId="257"/>
        </pc:sldMkLst>
        <pc:spChg chg="add del">
          <ac:chgData name="Janaina Aderaldo" userId="e0012194be11c710" providerId="LiveId" clId="{BE4EADF0-0C0B-4CEF-911B-90F73FB92925}" dt="2023-01-09T09:42:11" v="2" actId="22"/>
          <ac:spMkLst>
            <pc:docMk/>
            <pc:sldMk cId="3959218598" sldId="257"/>
            <ac:spMk id="4" creationId="{7F26DF37-C42B-4F14-697E-6D41255B3ADC}"/>
          </ac:spMkLst>
        </pc:spChg>
        <pc:picChg chg="add">
          <ac:chgData name="Janaina Aderaldo" userId="e0012194be11c710" providerId="LiveId" clId="{BE4EADF0-0C0B-4CEF-911B-90F73FB92925}" dt="2023-01-09T09:42:32.743" v="3" actId="22"/>
          <ac:picMkLst>
            <pc:docMk/>
            <pc:sldMk cId="3959218598" sldId="257"/>
            <ac:picMk id="6" creationId="{8FF1D2FE-E4EB-F08D-7CC8-0D052F4CB8C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69EE9-07A8-024E-A01A-6209D8E9D629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EAB74-989D-0C49-BB72-C9B1BCCB3A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04023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69EE9-07A8-024E-A01A-6209D8E9D629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EAB74-989D-0C49-BB72-C9B1BCCB3A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013464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69EE9-07A8-024E-A01A-6209D8E9D629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EAB74-989D-0C49-BB72-C9B1BCCB3A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56450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69EE9-07A8-024E-A01A-6209D8E9D629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EAB74-989D-0C49-BB72-C9B1BCCB3A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54153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69EE9-07A8-024E-A01A-6209D8E9D629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EAB74-989D-0C49-BB72-C9B1BCCB3A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07898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69EE9-07A8-024E-A01A-6209D8E9D629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EAB74-989D-0C49-BB72-C9B1BCCB3A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00542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69EE9-07A8-024E-A01A-6209D8E9D629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EAB74-989D-0C49-BB72-C9B1BCCB3A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82550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69EE9-07A8-024E-A01A-6209D8E9D629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EAB74-989D-0C49-BB72-C9B1BCCB3A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08121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69EE9-07A8-024E-A01A-6209D8E9D629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EAB74-989D-0C49-BB72-C9B1BCCB3A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40233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69EE9-07A8-024E-A01A-6209D8E9D629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EAB74-989D-0C49-BB72-C9B1BCCB3A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63909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69EE9-07A8-024E-A01A-6209D8E9D629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EAB74-989D-0C49-BB72-C9B1BCCB3A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31791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A69EE9-07A8-024E-A01A-6209D8E9D629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EAB74-989D-0C49-BB72-C9B1BCCB3A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1462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CaixaDeTexto 17">
            <a:extLst>
              <a:ext uri="{FF2B5EF4-FFF2-40B4-BE49-F238E27FC236}">
                <a16:creationId xmlns:a16="http://schemas.microsoft.com/office/drawing/2014/main" id="{45777509-FBBB-7A4D-AFF1-5100379E1C1D}"/>
              </a:ext>
            </a:extLst>
          </p:cNvPr>
          <p:cNvSpPr txBox="1"/>
          <p:nvPr/>
        </p:nvSpPr>
        <p:spPr>
          <a:xfrm>
            <a:off x="183413" y="4811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/>
              <a:t>A</a:t>
            </a:r>
          </a:p>
        </p:txBody>
      </p: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099A9CD4-B024-5F4D-B471-119428DA5039}"/>
              </a:ext>
            </a:extLst>
          </p:cNvPr>
          <p:cNvSpPr txBox="1"/>
          <p:nvPr/>
        </p:nvSpPr>
        <p:spPr>
          <a:xfrm>
            <a:off x="256645" y="7180082"/>
            <a:ext cx="6144155" cy="101566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pt-BR" sz="1200" dirty="0">
                <a:latin typeface="Times"/>
                <a:cs typeface="Times"/>
              </a:rPr>
              <a:t>S1 Fig. </a:t>
            </a:r>
            <a:r>
              <a:rPr lang="pt-BR" sz="1200" dirty="0" err="1">
                <a:latin typeface="Times"/>
                <a:cs typeface="Times"/>
              </a:rPr>
              <a:t>Eligible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clinical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outcomes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studies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dispersion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lots</a:t>
            </a:r>
            <a:r>
              <a:rPr lang="pt-BR" sz="1200" dirty="0">
                <a:latin typeface="Times"/>
                <a:cs typeface="Times"/>
              </a:rPr>
              <a:t>. A) </a:t>
            </a:r>
            <a:r>
              <a:rPr lang="pt-BR" sz="1200" dirty="0" err="1">
                <a:latin typeface="Times"/>
                <a:cs typeface="Times"/>
              </a:rPr>
              <a:t>clinical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regnancy</a:t>
            </a:r>
            <a:r>
              <a:rPr lang="pt-BR" sz="1200" dirty="0">
                <a:latin typeface="Times"/>
                <a:cs typeface="Times"/>
              </a:rPr>
              <a:t> for </a:t>
            </a:r>
            <a:r>
              <a:rPr lang="pt-BR" sz="1200" dirty="0" err="1">
                <a:latin typeface="Times"/>
                <a:cs typeface="Times"/>
              </a:rPr>
              <a:t>sperm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sporter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technique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dispersion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lot</a:t>
            </a:r>
            <a:r>
              <a:rPr lang="pt-BR" sz="1200" dirty="0">
                <a:latin typeface="Times"/>
                <a:cs typeface="Times"/>
              </a:rPr>
              <a:t>; B) </a:t>
            </a:r>
            <a:r>
              <a:rPr lang="pt-BR" sz="1200" dirty="0" err="1">
                <a:latin typeface="Times"/>
                <a:cs typeface="Times"/>
              </a:rPr>
              <a:t>miscarriage</a:t>
            </a:r>
            <a:r>
              <a:rPr lang="pt-BR" sz="1200" dirty="0">
                <a:latin typeface="Times"/>
                <a:cs typeface="Times"/>
              </a:rPr>
              <a:t> for </a:t>
            </a:r>
            <a:r>
              <a:rPr lang="pt-BR" sz="1200" dirty="0" err="1">
                <a:latin typeface="Times"/>
                <a:cs typeface="Times"/>
              </a:rPr>
              <a:t>sperm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sorter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technique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dispersion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lot</a:t>
            </a:r>
            <a:r>
              <a:rPr lang="pt-BR" sz="1200" dirty="0">
                <a:latin typeface="Times"/>
                <a:cs typeface="Times"/>
              </a:rPr>
              <a:t>;  C) </a:t>
            </a:r>
            <a:r>
              <a:rPr lang="pt-BR" sz="1200" dirty="0" err="1">
                <a:latin typeface="Times"/>
                <a:cs typeface="Times"/>
              </a:rPr>
              <a:t>clinical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regnancy</a:t>
            </a:r>
            <a:r>
              <a:rPr lang="pt-BR" sz="1200" dirty="0">
                <a:latin typeface="Times"/>
                <a:cs typeface="Times"/>
              </a:rPr>
              <a:t> for </a:t>
            </a:r>
            <a:r>
              <a:rPr lang="pt-BR" sz="1200" dirty="0" err="1">
                <a:latin typeface="Times"/>
                <a:cs typeface="Times"/>
              </a:rPr>
              <a:t>groups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control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dispersion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lot</a:t>
            </a:r>
            <a:r>
              <a:rPr lang="pt-BR" sz="1200" dirty="0">
                <a:latin typeface="Times"/>
                <a:cs typeface="Times"/>
              </a:rPr>
              <a:t>; D) </a:t>
            </a:r>
            <a:r>
              <a:rPr lang="pt-BR" sz="1200" dirty="0" err="1">
                <a:latin typeface="Times"/>
                <a:cs typeface="Times"/>
              </a:rPr>
              <a:t>miscarriage</a:t>
            </a:r>
            <a:r>
              <a:rPr lang="pt-BR" sz="1200" dirty="0">
                <a:latin typeface="Times"/>
                <a:cs typeface="Times"/>
              </a:rPr>
              <a:t> for </a:t>
            </a:r>
            <a:r>
              <a:rPr lang="pt-BR" sz="1200" dirty="0" err="1">
                <a:latin typeface="Times"/>
                <a:cs typeface="Times"/>
              </a:rPr>
              <a:t>groups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control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dispersion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lot</a:t>
            </a:r>
            <a:r>
              <a:rPr lang="pt-BR" sz="1200" dirty="0">
                <a:latin typeface="Times"/>
                <a:cs typeface="Times"/>
              </a:rPr>
              <a:t>; E) </a:t>
            </a:r>
            <a:r>
              <a:rPr lang="pt-BR" sz="1200" dirty="0" err="1">
                <a:latin typeface="Times"/>
                <a:cs typeface="Times"/>
              </a:rPr>
              <a:t>clinical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regnancy</a:t>
            </a:r>
            <a:r>
              <a:rPr lang="pt-BR" sz="1200" dirty="0">
                <a:latin typeface="Times"/>
                <a:cs typeface="Times"/>
              </a:rPr>
              <a:t> for </a:t>
            </a:r>
            <a:r>
              <a:rPr lang="pt-BR" sz="1200" dirty="0" err="1">
                <a:latin typeface="Times"/>
                <a:cs typeface="Times"/>
              </a:rPr>
              <a:t>embryo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biopsy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dispersion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lot</a:t>
            </a:r>
            <a:r>
              <a:rPr lang="pt-BR" sz="1200" dirty="0">
                <a:latin typeface="Times"/>
                <a:cs typeface="Times"/>
              </a:rPr>
              <a:t>; F) </a:t>
            </a:r>
            <a:r>
              <a:rPr lang="pt-BR" sz="1200" dirty="0" err="1">
                <a:latin typeface="Times"/>
                <a:cs typeface="Times"/>
              </a:rPr>
              <a:t>miscarriage</a:t>
            </a:r>
            <a:r>
              <a:rPr lang="pt-BR" sz="1200" dirty="0">
                <a:latin typeface="Times"/>
                <a:cs typeface="Times"/>
              </a:rPr>
              <a:t> for </a:t>
            </a:r>
            <a:r>
              <a:rPr lang="pt-BR" sz="1200" dirty="0" err="1">
                <a:latin typeface="Times"/>
                <a:cs typeface="Times"/>
              </a:rPr>
              <a:t>embryo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biopsy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dispersion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lot</a:t>
            </a:r>
            <a:r>
              <a:rPr lang="pt-BR" sz="1200" dirty="0">
                <a:latin typeface="Times"/>
                <a:cs typeface="Times"/>
              </a:rPr>
              <a:t>.</a:t>
            </a:r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76D94819-7B58-9946-8356-4319501C9D84}"/>
              </a:ext>
            </a:extLst>
          </p:cNvPr>
          <p:cNvSpPr txBox="1"/>
          <p:nvPr/>
        </p:nvSpPr>
        <p:spPr>
          <a:xfrm>
            <a:off x="3478043" y="48115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/>
              <a:t>B</a:t>
            </a: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5AD4CC3F-02CB-EC47-BCC6-8F505DD4C900}"/>
              </a:ext>
            </a:extLst>
          </p:cNvPr>
          <p:cNvSpPr txBox="1"/>
          <p:nvPr/>
        </p:nvSpPr>
        <p:spPr>
          <a:xfrm>
            <a:off x="189024" y="2325809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/>
              <a:t>C</a:t>
            </a:r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33EADA68-5597-CB43-9819-273C567FB1DA}"/>
              </a:ext>
            </a:extLst>
          </p:cNvPr>
          <p:cNvSpPr txBox="1"/>
          <p:nvPr/>
        </p:nvSpPr>
        <p:spPr>
          <a:xfrm>
            <a:off x="3482165" y="2325809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 err="1"/>
              <a:t>D</a:t>
            </a:r>
            <a:endParaRPr lang="pt-BR" sz="2000" b="1" dirty="0"/>
          </a:p>
        </p:txBody>
      </p:sp>
      <p:sp>
        <p:nvSpPr>
          <p:cNvPr id="20" name="CaixaDeTexto 19">
            <a:extLst>
              <a:ext uri="{FF2B5EF4-FFF2-40B4-BE49-F238E27FC236}">
                <a16:creationId xmlns:a16="http://schemas.microsoft.com/office/drawing/2014/main" id="{EF82739B-ABE6-E540-8946-165351361045}"/>
              </a:ext>
            </a:extLst>
          </p:cNvPr>
          <p:cNvSpPr txBox="1"/>
          <p:nvPr/>
        </p:nvSpPr>
        <p:spPr>
          <a:xfrm>
            <a:off x="3478043" y="4625275"/>
            <a:ext cx="3016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 err="1"/>
              <a:t>F</a:t>
            </a:r>
            <a:endParaRPr lang="pt-BR" sz="2000" b="1" dirty="0"/>
          </a:p>
        </p:txBody>
      </p:sp>
      <p:sp>
        <p:nvSpPr>
          <p:cNvPr id="23" name="CaixaDeTexto 22">
            <a:extLst>
              <a:ext uri="{FF2B5EF4-FFF2-40B4-BE49-F238E27FC236}">
                <a16:creationId xmlns:a16="http://schemas.microsoft.com/office/drawing/2014/main" id="{AEC6C648-5B92-4A41-B71F-0BF96B359345}"/>
              </a:ext>
            </a:extLst>
          </p:cNvPr>
          <p:cNvSpPr txBox="1"/>
          <p:nvPr/>
        </p:nvSpPr>
        <p:spPr>
          <a:xfrm>
            <a:off x="183413" y="4625275"/>
            <a:ext cx="309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/>
              <a:t>E</a:t>
            </a:r>
          </a:p>
        </p:txBody>
      </p:sp>
      <p:pic>
        <p:nvPicPr>
          <p:cNvPr id="4" name="Imagem 3">
            <a:extLst>
              <a:ext uri="{FF2B5EF4-FFF2-40B4-BE49-F238E27FC236}">
                <a16:creationId xmlns:a16="http://schemas.microsoft.com/office/drawing/2014/main" id="{62A6470E-3018-6302-31B1-F6CDD2266D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9366" y="336052"/>
            <a:ext cx="2880000" cy="2054400"/>
          </a:xfrm>
          <a:prstGeom prst="rect">
            <a:avLst/>
          </a:prstGeom>
        </p:spPr>
      </p:pic>
      <p:pic>
        <p:nvPicPr>
          <p:cNvPr id="3" name="Imagem 2">
            <a:extLst>
              <a:ext uri="{FF2B5EF4-FFF2-40B4-BE49-F238E27FC236}">
                <a16:creationId xmlns:a16="http://schemas.microsoft.com/office/drawing/2014/main" id="{EF856564-5AE3-E77E-EDB1-B7425BD473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8886" y="336052"/>
            <a:ext cx="2880000" cy="2054400"/>
          </a:xfrm>
          <a:prstGeom prst="rect">
            <a:avLst/>
          </a:prstGeom>
        </p:spPr>
      </p:pic>
      <p:pic>
        <p:nvPicPr>
          <p:cNvPr id="6" name="Imagem 5">
            <a:extLst>
              <a:ext uri="{FF2B5EF4-FFF2-40B4-BE49-F238E27FC236}">
                <a16:creationId xmlns:a16="http://schemas.microsoft.com/office/drawing/2014/main" id="{0145DE5E-E9A9-232E-73FF-F8DA532722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9366" y="2678389"/>
            <a:ext cx="2880000" cy="2054400"/>
          </a:xfrm>
          <a:prstGeom prst="rect">
            <a:avLst/>
          </a:prstGeom>
        </p:spPr>
      </p:pic>
      <p:pic>
        <p:nvPicPr>
          <p:cNvPr id="8" name="Imagem 7">
            <a:extLst>
              <a:ext uri="{FF2B5EF4-FFF2-40B4-BE49-F238E27FC236}">
                <a16:creationId xmlns:a16="http://schemas.microsoft.com/office/drawing/2014/main" id="{54B8DE21-A6B4-1E16-60B7-CF5055C9DEE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28886" y="2689171"/>
            <a:ext cx="2880000" cy="2054400"/>
          </a:xfrm>
          <a:prstGeom prst="rect">
            <a:avLst/>
          </a:prstGeom>
        </p:spPr>
      </p:pic>
      <p:pic>
        <p:nvPicPr>
          <p:cNvPr id="13" name="Imagem 12">
            <a:extLst>
              <a:ext uri="{FF2B5EF4-FFF2-40B4-BE49-F238E27FC236}">
                <a16:creationId xmlns:a16="http://schemas.microsoft.com/office/drawing/2014/main" id="{6ED4DCB8-602E-3DB3-5BD6-E9EDE5FDEF2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9366" y="5020726"/>
            <a:ext cx="2880000" cy="2054400"/>
          </a:xfrm>
          <a:prstGeom prst="rect">
            <a:avLst/>
          </a:prstGeom>
        </p:spPr>
      </p:pic>
      <p:pic>
        <p:nvPicPr>
          <p:cNvPr id="16" name="Imagem 15">
            <a:extLst>
              <a:ext uri="{FF2B5EF4-FFF2-40B4-BE49-F238E27FC236}">
                <a16:creationId xmlns:a16="http://schemas.microsoft.com/office/drawing/2014/main" id="{CF6B5420-CBB6-E893-0C0E-5A3A18839D2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20800" y="5020726"/>
            <a:ext cx="2880000" cy="205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85389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CaixaDeTexto 17">
            <a:extLst>
              <a:ext uri="{FF2B5EF4-FFF2-40B4-BE49-F238E27FC236}">
                <a16:creationId xmlns:a16="http://schemas.microsoft.com/office/drawing/2014/main" id="{45777509-FBBB-7A4D-AFF1-5100379E1C1D}"/>
              </a:ext>
            </a:extLst>
          </p:cNvPr>
          <p:cNvSpPr txBox="1"/>
          <p:nvPr/>
        </p:nvSpPr>
        <p:spPr>
          <a:xfrm>
            <a:off x="183413" y="4811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/>
              <a:t>A</a:t>
            </a:r>
          </a:p>
        </p:txBody>
      </p: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099A9CD4-B024-5F4D-B471-119428DA5039}"/>
              </a:ext>
            </a:extLst>
          </p:cNvPr>
          <p:cNvSpPr txBox="1"/>
          <p:nvPr/>
        </p:nvSpPr>
        <p:spPr>
          <a:xfrm>
            <a:off x="256645" y="7180082"/>
            <a:ext cx="6144155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pt-BR" sz="1200" dirty="0">
                <a:latin typeface="Times"/>
                <a:cs typeface="Times"/>
              </a:rPr>
              <a:t>S2 Fig. </a:t>
            </a:r>
            <a:r>
              <a:rPr lang="pt-BR" sz="1200" dirty="0" err="1">
                <a:latin typeface="Times"/>
                <a:cs typeface="Times"/>
              </a:rPr>
              <a:t>Eligible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laboratory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outcomestudies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dispersion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lots</a:t>
            </a:r>
            <a:r>
              <a:rPr lang="pt-BR" sz="1200" dirty="0">
                <a:latin typeface="Times"/>
                <a:cs typeface="Times"/>
              </a:rPr>
              <a:t>. A) </a:t>
            </a:r>
            <a:r>
              <a:rPr lang="pt-BR" sz="1200" dirty="0" err="1">
                <a:latin typeface="Times"/>
                <a:cs typeface="Times"/>
              </a:rPr>
              <a:t>fertilization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dispersion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lot</a:t>
            </a:r>
            <a:r>
              <a:rPr lang="pt-BR" sz="1200" dirty="0">
                <a:latin typeface="Times"/>
                <a:cs typeface="Times"/>
              </a:rPr>
              <a:t>; B) </a:t>
            </a:r>
            <a:r>
              <a:rPr lang="pt-BR" sz="1200" dirty="0" err="1">
                <a:latin typeface="Times"/>
                <a:cs typeface="Times"/>
              </a:rPr>
              <a:t>blastocyst</a:t>
            </a:r>
            <a:r>
              <a:rPr lang="pt-BR" sz="1200" dirty="0">
                <a:latin typeface="Times"/>
                <a:cs typeface="Times"/>
              </a:rPr>
              <a:t> rate </a:t>
            </a:r>
            <a:r>
              <a:rPr lang="pt-BR" sz="1200" dirty="0" err="1">
                <a:latin typeface="Times"/>
                <a:cs typeface="Times"/>
              </a:rPr>
              <a:t>dispersion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lot</a:t>
            </a:r>
            <a:r>
              <a:rPr lang="pt-BR" sz="1200" dirty="0">
                <a:latin typeface="Times"/>
                <a:cs typeface="Times"/>
              </a:rPr>
              <a:t>;  C) </a:t>
            </a:r>
            <a:r>
              <a:rPr lang="pt-BR" sz="1200" dirty="0" err="1">
                <a:latin typeface="Times"/>
                <a:cs typeface="Times"/>
              </a:rPr>
              <a:t>blastocysts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good</a:t>
            </a:r>
            <a:r>
              <a:rPr lang="pt-BR" sz="1200" dirty="0">
                <a:latin typeface="Times"/>
                <a:cs typeface="Times"/>
              </a:rPr>
              <a:t>/</a:t>
            </a:r>
            <a:r>
              <a:rPr lang="pt-BR" sz="1200" dirty="0" err="1">
                <a:latin typeface="Times"/>
                <a:cs typeface="Times"/>
              </a:rPr>
              <a:t>excelent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dispersion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lot</a:t>
            </a:r>
            <a:r>
              <a:rPr lang="pt-BR" sz="1200" dirty="0">
                <a:latin typeface="Times"/>
                <a:cs typeface="Times"/>
              </a:rPr>
              <a:t>; D) </a:t>
            </a:r>
            <a:r>
              <a:rPr lang="pt-BR" sz="1200" dirty="0" err="1">
                <a:latin typeface="Times"/>
                <a:cs typeface="Times"/>
              </a:rPr>
              <a:t>euploidy</a:t>
            </a:r>
            <a:r>
              <a:rPr lang="pt-BR" sz="1200" dirty="0">
                <a:latin typeface="Times"/>
                <a:cs typeface="Times"/>
              </a:rPr>
              <a:t> rate </a:t>
            </a:r>
            <a:r>
              <a:rPr lang="pt-BR" sz="1200" dirty="0" err="1">
                <a:latin typeface="Times"/>
                <a:cs typeface="Times"/>
              </a:rPr>
              <a:t>dispersion</a:t>
            </a:r>
            <a:r>
              <a:rPr lang="pt-BR" sz="1200" dirty="0">
                <a:latin typeface="Times"/>
                <a:cs typeface="Times"/>
              </a:rPr>
              <a:t> </a:t>
            </a:r>
            <a:r>
              <a:rPr lang="pt-BR" sz="1200" dirty="0" err="1">
                <a:latin typeface="Times"/>
                <a:cs typeface="Times"/>
              </a:rPr>
              <a:t>plot</a:t>
            </a:r>
            <a:r>
              <a:rPr lang="pt-BR" sz="1200" dirty="0">
                <a:latin typeface="Times"/>
                <a:cs typeface="Times"/>
              </a:rPr>
              <a:t>.</a:t>
            </a:r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76D94819-7B58-9946-8356-4319501C9D84}"/>
              </a:ext>
            </a:extLst>
          </p:cNvPr>
          <p:cNvSpPr txBox="1"/>
          <p:nvPr/>
        </p:nvSpPr>
        <p:spPr>
          <a:xfrm>
            <a:off x="3478043" y="48115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/>
              <a:t>B</a:t>
            </a: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5AD4CC3F-02CB-EC47-BCC6-8F505DD4C900}"/>
              </a:ext>
            </a:extLst>
          </p:cNvPr>
          <p:cNvSpPr txBox="1"/>
          <p:nvPr/>
        </p:nvSpPr>
        <p:spPr>
          <a:xfrm>
            <a:off x="189024" y="2325809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/>
              <a:t>C</a:t>
            </a:r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33EADA68-5597-CB43-9819-273C567FB1DA}"/>
              </a:ext>
            </a:extLst>
          </p:cNvPr>
          <p:cNvSpPr txBox="1"/>
          <p:nvPr/>
        </p:nvSpPr>
        <p:spPr>
          <a:xfrm>
            <a:off x="3482165" y="2325809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 err="1"/>
              <a:t>D</a:t>
            </a:r>
            <a:endParaRPr lang="pt-BR" sz="2000" b="1" dirty="0"/>
          </a:p>
        </p:txBody>
      </p:sp>
      <p:pic>
        <p:nvPicPr>
          <p:cNvPr id="3" name="Imagem 2">
            <a:extLst>
              <a:ext uri="{FF2B5EF4-FFF2-40B4-BE49-F238E27FC236}">
                <a16:creationId xmlns:a16="http://schemas.microsoft.com/office/drawing/2014/main" id="{98FEF230-BDAD-653B-DF87-189BFAF81C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645" y="353911"/>
            <a:ext cx="2880000" cy="2054400"/>
          </a:xfrm>
          <a:prstGeom prst="rect">
            <a:avLst/>
          </a:prstGeom>
        </p:spPr>
      </p:pic>
      <p:pic>
        <p:nvPicPr>
          <p:cNvPr id="5" name="Imagem 4">
            <a:extLst>
              <a:ext uri="{FF2B5EF4-FFF2-40B4-BE49-F238E27FC236}">
                <a16:creationId xmlns:a16="http://schemas.microsoft.com/office/drawing/2014/main" id="{E9F87C2D-6270-A20A-05C3-9ECE9386D1E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51275" y="258773"/>
            <a:ext cx="2880000" cy="1920000"/>
          </a:xfrm>
          <a:prstGeom prst="rect">
            <a:avLst/>
          </a:prstGeom>
        </p:spPr>
      </p:pic>
      <p:pic>
        <p:nvPicPr>
          <p:cNvPr id="7" name="Imagem 6">
            <a:extLst>
              <a:ext uri="{FF2B5EF4-FFF2-40B4-BE49-F238E27FC236}">
                <a16:creationId xmlns:a16="http://schemas.microsoft.com/office/drawing/2014/main" id="{1E32558E-9510-ABA9-F504-4C6E2DC56B8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6645" y="2676912"/>
            <a:ext cx="2880000" cy="1920000"/>
          </a:xfrm>
          <a:prstGeom prst="rect">
            <a:avLst/>
          </a:prstGeom>
        </p:spPr>
      </p:pic>
      <p:pic>
        <p:nvPicPr>
          <p:cNvPr id="11" name="Imagem 10">
            <a:extLst>
              <a:ext uri="{FF2B5EF4-FFF2-40B4-BE49-F238E27FC236}">
                <a16:creationId xmlns:a16="http://schemas.microsoft.com/office/drawing/2014/main" id="{BA9F05F7-EA40-339A-9378-650CFAE5118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51275" y="2675727"/>
            <a:ext cx="2880000" cy="19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829055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46</TotalTime>
  <Words>117</Words>
  <Application>Microsoft Office PowerPoint</Application>
  <PresentationFormat>Papel A4 (210 x 297 mm)</PresentationFormat>
  <Paragraphs>12</Paragraphs>
  <Slides>2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</vt:lpstr>
      <vt:lpstr>Tema do Office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Janaina Aderaldo</dc:creator>
  <cp:lastModifiedBy>Janaina Ferreira Aderaldo</cp:lastModifiedBy>
  <cp:revision>3</cp:revision>
  <dcterms:created xsi:type="dcterms:W3CDTF">2022-03-31T13:23:42Z</dcterms:created>
  <dcterms:modified xsi:type="dcterms:W3CDTF">2023-08-07T19:37:29Z</dcterms:modified>
</cp:coreProperties>
</file>